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628DC7F-C499-4D10-889A-115207A27E8A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9C890E1-6E1D-499B-B4AF-168ED31AD705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126077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8" name="Zástupný symbol pro obrázek snímku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9459" name="Zástupný symbol pro poznámky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cs-CZ" altLang="cs-CZ" b="1" smtClean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CE09B0BD-35D3-4624-AD5B-CA537D54A95D}" type="slidenum">
              <a:rPr lang="fr-FR" smtClean="0"/>
              <a:pPr>
                <a:defRPr/>
              </a:pPr>
              <a:t>1</a:t>
            </a:fld>
            <a:endParaRPr lang="fr-FR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7816346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2186270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232529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3656785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2594649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5822763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680069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885120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5227896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1369287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2046774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10EB35-E965-428C-BEE3-6E410B699C05}" type="datetimeFigureOut">
              <a:rPr lang="cs-CZ" smtClean="0"/>
              <a:t>10.10.2014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F99E92-317A-40E8-99DA-CA09ECBE8E03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7397313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94" name="Obdélník 4"/>
          <p:cNvSpPr>
            <a:spLocks noChangeArrowheads="1"/>
          </p:cNvSpPr>
          <p:nvPr/>
        </p:nvSpPr>
        <p:spPr bwMode="auto">
          <a:xfrm>
            <a:off x="323850" y="3141663"/>
            <a:ext cx="8064500" cy="1200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just">
              <a:buFont typeface="Arial" charset="0"/>
              <a:buNone/>
            </a:pP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Additional file 7. Content of photosynthetic pigments (µg/ g DW) in four weeks old tomato developing leaves of WT and T2-generation tomato </a:t>
            </a:r>
            <a:r>
              <a:rPr lang="cs-CZ" altLang="cs-CZ" sz="1200" b="1" i="1">
                <a:latin typeface="Helvetica" pitchFamily="34" charset="0"/>
                <a:cs typeface="Helvetica" pitchFamily="34" charset="0"/>
              </a:rPr>
              <a:t>35S::SlIPT3 </a:t>
            </a:r>
            <a:r>
              <a:rPr lang="cs-CZ" altLang="cs-CZ" sz="1200" b="1">
                <a:latin typeface="Helvetica" pitchFamily="34" charset="0"/>
                <a:cs typeface="Helvetica" pitchFamily="34" charset="0"/>
              </a:rPr>
              <a:t>(L1) plants cultivated on the control and salt media. </a:t>
            </a:r>
            <a:r>
              <a:rPr lang="cs-CZ" altLang="cs-CZ" sz="1200">
                <a:latin typeface="Helvetica" pitchFamily="34" charset="0"/>
                <a:cs typeface="Helvetica" pitchFamily="34" charset="0"/>
              </a:rPr>
              <a:t>DEPS (De-epoxidation state) is calculated according to formula: DEPS=(0.5*A+Z)/(V+A+Z); DEPS (De-epoxidation state per chlorophyll) is calculated according to formula: DEPSC=(0.5*A+Z)/(Chl </a:t>
            </a:r>
            <a:r>
              <a:rPr lang="cs-CZ" altLang="cs-CZ" sz="1200" i="1">
                <a:latin typeface="Helvetica" pitchFamily="34" charset="0"/>
                <a:cs typeface="Helvetica" pitchFamily="34" charset="0"/>
              </a:rPr>
              <a:t>a</a:t>
            </a:r>
            <a:r>
              <a:rPr lang="cs-CZ" altLang="cs-CZ" sz="1200">
                <a:latin typeface="Helvetica" pitchFamily="34" charset="0"/>
                <a:cs typeface="Helvetica" pitchFamily="34" charset="0"/>
              </a:rPr>
              <a:t>+</a:t>
            </a:r>
            <a:r>
              <a:rPr lang="cs-CZ" altLang="cs-CZ" sz="1200" i="1">
                <a:latin typeface="Helvetica" pitchFamily="34" charset="0"/>
                <a:cs typeface="Helvetica" pitchFamily="34" charset="0"/>
              </a:rPr>
              <a:t>b</a:t>
            </a:r>
            <a:r>
              <a:rPr lang="cs-CZ" altLang="cs-CZ" sz="1200">
                <a:latin typeface="Helvetica" pitchFamily="34" charset="0"/>
                <a:cs typeface="Helvetica" pitchFamily="34" charset="0"/>
              </a:rPr>
              <a:t>). </a:t>
            </a:r>
            <a:r>
              <a:rPr lang="cs-CZ" altLang="cs-CZ" sz="1200">
                <a:latin typeface="Times New Roman" pitchFamily="18" charset="0"/>
                <a:cs typeface="Times New Roman" pitchFamily="18" charset="0"/>
              </a:rPr>
              <a:t>^</a:t>
            </a:r>
            <a:r>
              <a:rPr lang="cs-CZ" altLang="cs-CZ" sz="1200">
                <a:latin typeface="Helvetica" pitchFamily="34" charset="0"/>
                <a:cs typeface="Helvetica" pitchFamily="34" charset="0"/>
              </a:rPr>
              <a:t> expressed in relative unit. * Data represent means and SD of two replicates.* significantly different datasets from WT(unpaired Student's </a:t>
            </a:r>
            <a:r>
              <a:rPr lang="cs-CZ" altLang="cs-CZ" sz="1200" i="1">
                <a:latin typeface="Helvetica" pitchFamily="34" charset="0"/>
                <a:cs typeface="Helvetica" pitchFamily="34" charset="0"/>
              </a:rPr>
              <a:t>t</a:t>
            </a:r>
            <a:r>
              <a:rPr lang="cs-CZ" altLang="cs-CZ" sz="1200">
                <a:latin typeface="Helvetica" pitchFamily="34" charset="0"/>
                <a:cs typeface="Helvetica" pitchFamily="34" charset="0"/>
              </a:rPr>
              <a:t>-test, P ≤ 0.05).</a:t>
            </a:r>
          </a:p>
        </p:txBody>
      </p:sp>
      <p:graphicFrame>
        <p:nvGraphicFramePr>
          <p:cNvPr id="5" name="Group 50"/>
          <p:cNvGraphicFramePr>
            <a:graphicFrameLocks/>
          </p:cNvGraphicFramePr>
          <p:nvPr/>
        </p:nvGraphicFramePr>
        <p:xfrm>
          <a:off x="323850" y="404813"/>
          <a:ext cx="8280400" cy="2536823"/>
        </p:xfrm>
        <a:graphic>
          <a:graphicData uri="http://schemas.openxmlformats.org/drawingml/2006/table">
            <a:tbl>
              <a:tblPr/>
              <a:tblGrid>
                <a:gridCol w="1804233"/>
                <a:gridCol w="1082540"/>
                <a:gridCol w="1113081"/>
                <a:gridCol w="1052593"/>
                <a:gridCol w="1022288"/>
                <a:gridCol w="1129274"/>
                <a:gridCol w="1076391"/>
              </a:tblGrid>
              <a:tr h="192404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gridSpan="3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T (µg/ g DW)</a:t>
                      </a:r>
                      <a:endParaRPr lang="cs-CZ" sz="1200" b="1" i="0" u="none" strike="noStrike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gridSpan="3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200" b="1" i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S::SlIPT3 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µg/ g DW</a:t>
                      </a:r>
                      <a:r>
                        <a:rPr kumimoji="0" lang="cs-CZ" sz="1200" b="1" i="0" u="none" strike="noStrike" cap="none" normalizeH="0" baseline="0" dirty="0" smtClean="0">
                          <a:ln>
                            <a:noFill/>
                          </a:ln>
                          <a:solidFill>
                            <a:schemeClr val="bg1"/>
                          </a:solidFill>
                          <a:effectLst/>
                          <a:latin typeface="Times New Roman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cs-CZ" sz="1200" b="1" i="1" u="none" strike="noStrike" dirty="0" smtClean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 hMerge="1"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0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6" marR="9526" marT="9525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</a:tr>
              <a:tr h="260491"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</a:pPr>
                      <a:endParaRPr kumimoji="0" lang="cs-CZ" altLang="cs-CZ" sz="1200" b="1" i="1" u="none" strike="noStrike" cap="none" normalizeH="0" baseline="0" dirty="0" smtClean="0">
                        <a:ln>
                          <a:noFill/>
                        </a:ln>
                        <a:solidFill>
                          <a:schemeClr val="bg1"/>
                        </a:solidFill>
                        <a:effectLst/>
                        <a:latin typeface="Times New Roman" pitchFamily="18" charset="0"/>
                        <a:cs typeface="Helvetica" pitchFamily="34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l</a:t>
                      </a:r>
                      <a:endParaRPr lang="cs-CZ" sz="1100" b="1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l</a:t>
                      </a:r>
                      <a:endParaRPr lang="cs-CZ" sz="1100" b="1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S</a:t>
                      </a: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0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l</a:t>
                      </a:r>
                      <a:endParaRPr lang="cs-CZ" sz="1100" b="1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>
                      <a:lvl1pPr eaLnBrk="0" hangingPunct="0">
                        <a:spcBef>
                          <a:spcPct val="20000"/>
                        </a:spcBef>
                        <a:buFont typeface="Arial" pitchFamily="34" charset="0"/>
                        <a:defRPr sz="28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1pPr>
                      <a:lvl2pPr marL="742950" indent="-285750" eaLnBrk="0" hangingPunct="0">
                        <a:spcBef>
                          <a:spcPct val="20000"/>
                        </a:spcBef>
                        <a:buFont typeface="Arial" pitchFamily="34" charset="0"/>
                        <a:defRPr sz="24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2pPr>
                      <a:lvl3pPr marL="11430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 sz="2000"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3pPr>
                      <a:lvl4pPr marL="16002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4pPr>
                      <a:lvl5pPr marL="2057400" indent="-228600" eaLnBrk="0" hangingPunct="0">
                        <a:spcBef>
                          <a:spcPct val="20000"/>
                        </a:spcBef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5pPr>
                      <a:lvl6pPr marL="25146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6pPr>
                      <a:lvl7pPr marL="29718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7pPr>
                      <a:lvl8pPr marL="34290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8pPr>
                      <a:lvl9pPr marL="3886200" indent="-228600" eaLnBrk="0" fontAlgn="base" hangingPunct="0">
                        <a:spcBef>
                          <a:spcPct val="20000"/>
                        </a:spcBef>
                        <a:spcAft>
                          <a:spcPct val="0"/>
                        </a:spcAft>
                        <a:buFont typeface="Arial" pitchFamily="34" charset="0"/>
                        <a:defRPr>
                          <a:solidFill>
                            <a:schemeClr val="tx1"/>
                          </a:solidFill>
                          <a:latin typeface="Calibri" pitchFamily="34" charset="0"/>
                        </a:defRPr>
                      </a:lvl9pPr>
                    </a:lstStyle>
                    <a:p>
                      <a:pPr marL="0" marR="0" lvl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ct val="0"/>
                        </a:spcBef>
                        <a:spcAft>
                          <a:spcPct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0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cs-CZ" sz="1100" b="1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100" b="1" u="none" strike="noStrike" dirty="0" err="1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aCl</a:t>
                      </a:r>
                      <a:endParaRPr lang="cs-CZ" sz="1100" b="1" i="0" u="none" strike="noStrike" dirty="0" smtClean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5" marR="9525" marT="9524" marB="0" anchor="ctr" horzOverflow="overflow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381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hyll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200" b="1" i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cs-CZ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+</a:t>
                      </a:r>
                      <a:r>
                        <a:rPr lang="cs-CZ" sz="1200" b="1" i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cs-CZ" sz="1200" b="1" i="1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24.30 ± 2.94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33 ± 3.11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1.13 ± 1.89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7.73 ± 0.38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5.98 ± 0.46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2.08 ± 1.01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hlorophyll</a:t>
                      </a:r>
                      <a:r>
                        <a:rPr lang="cs-CZ" sz="1200" b="1" u="none" strike="noStrike" dirty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cs-CZ" sz="1200" b="1" i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/</a:t>
                      </a:r>
                      <a:r>
                        <a:rPr lang="cs-CZ" sz="1200" b="1" i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^</a:t>
                      </a:r>
                      <a:endParaRPr lang="cs-CZ" sz="1200" b="1" i="1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0 ± 0.05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1 ± 0.01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6 ± 0.05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6 ± 0.03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2 ± 0.09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3 ± 0.07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iolaxanthin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V)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90 ± 0.34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13 ± 0.78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03 ± 0.66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4.23 ± 0.55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9.30 ± 0.29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.83 ± 0.45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heraxanthin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A) 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5 ± 0.13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5 ± 0.17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25 ± 0.4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05 ± 0.13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3 ± 0.22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48 ± 0.21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Zeaxanthin</a:t>
                      </a:r>
                      <a:r>
                        <a:rPr lang="cs-CZ" sz="1200" b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(Z)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73 ± 0.09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38 ± 0.15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39 ± 0.27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50 ± 0.34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92 ± 0.80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6.25 ± 0.55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u="none" strike="noStrike" dirty="0" err="1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eoxanthin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33 ± 0.26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25 ± 0.33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8.18 ± 0.21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63 ± 0.05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1.00 ± 0.35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15 ± 0.26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SC</a:t>
                      </a:r>
                      <a:r>
                        <a:rPr lang="cs-CZ" sz="1200" b="1" i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^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5 ± 0.0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8 ± 0.0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0 ± 0.0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7 ± 0.0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3 ± 0.01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9 ± 0.00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rgbClr val="E9EDF4"/>
                    </a:solidFill>
                  </a:tcPr>
                </a:tc>
              </a:tr>
              <a:tr h="260491">
                <a:tc>
                  <a:txBody>
                    <a:bodyPr/>
                    <a:lstStyle/>
                    <a:p>
                      <a:pPr algn="ctr" fontAlgn="b"/>
                      <a:r>
                        <a:rPr lang="cs-CZ" sz="1200" b="1" i="0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EPS</a:t>
                      </a:r>
                      <a:r>
                        <a:rPr lang="cs-CZ" sz="1200" b="1" i="1" u="none" strike="noStrike" dirty="0" smtClean="0">
                          <a:solidFill>
                            <a:schemeClr val="bg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^</a:t>
                      </a:r>
                      <a:endParaRPr lang="cs-CZ" sz="1200" b="1" i="0" u="none" strike="noStrike" dirty="0">
                        <a:solidFill>
                          <a:schemeClr val="bg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4 ± 0.00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6 ± 0.01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7 ± 0.01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1 ± 0.02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8 ± 0.02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smtClean="0"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3 ± 0.01*</a:t>
                      </a:r>
                      <a:endParaRPr lang="cs-CZ" sz="11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9524" marR="9524" marT="9524" marB="0" anchor="b">
                    <a:lnL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bg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>
                      <a:noFill/>
                    </a:lnTlToBr>
                    <a:lnBlToTr>
                      <a:noFill/>
                    </a:lnBlToTr>
                    <a:solidFill>
                      <a:schemeClr val="accent1">
                        <a:lumMod val="40000"/>
                        <a:lumOff val="60000"/>
                      </a:schemeClr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96801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19</Words>
  <Application>Microsoft Office PowerPoint</Application>
  <PresentationFormat>Předvádění na obrazovce (4:3)</PresentationFormat>
  <Paragraphs>66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</cp:revision>
  <dcterms:created xsi:type="dcterms:W3CDTF">2014-10-10T16:03:29Z</dcterms:created>
  <dcterms:modified xsi:type="dcterms:W3CDTF">2014-10-10T16:03:53Z</dcterms:modified>
</cp:coreProperties>
</file>